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61" r:id="rId4"/>
    <p:sldId id="258" r:id="rId5"/>
    <p:sldId id="259" r:id="rId6"/>
    <p:sldId id="260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9" d="100"/>
          <a:sy n="69" d="100"/>
        </p:scale>
        <p:origin x="69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50CBEF-6024-445C-A78D-2910E1B2813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A64FC39-C20F-4761-B81E-AD002E3D9EB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A901C3-5A18-4136-AA9F-68215E67FD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972EE-441C-4F55-8652-0FC6AA39DD1C}" type="datetimeFigureOut">
              <a:rPr lang="en-US" smtClean="0"/>
              <a:t>11/1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D0D50F-BAF3-470A-9393-CAAECEE994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B2FA3F-E192-4F00-9E1C-AAD9D7E6F3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08014D-84B6-4C3F-9655-0787B3CC1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74634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0BB87E-F279-4572-9103-7EA2257E75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A8B1021-9572-4BA1-A3EA-5CAB39FADB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8BD558-0604-410B-A629-03E1BB8DC7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972EE-441C-4F55-8652-0FC6AA39DD1C}" type="datetimeFigureOut">
              <a:rPr lang="en-US" smtClean="0"/>
              <a:t>11/1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5D032D-090C-4E28-B951-77ECBE1C8D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35DF4D-1DF7-4041-B258-40D8A5312D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08014D-84B6-4C3F-9655-0787B3CC1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46038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B2F6516-E28B-42F8-86C6-F64A79FBB9B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27EB167-5028-4583-AC32-627B986CB3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2C7733-CA48-4AB0-AA2E-EB750223F0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972EE-441C-4F55-8652-0FC6AA39DD1C}" type="datetimeFigureOut">
              <a:rPr lang="en-US" smtClean="0"/>
              <a:t>11/1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5C2593-DED1-4726-9299-A36D56C9CF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3677CE-904E-40C0-9E43-A7A4E3A5E3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08014D-84B6-4C3F-9655-0787B3CC1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153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4B5B73-28F8-477D-83F7-9DF51437EA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E056B93-D42F-4C4E-805B-1845EF569ED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23B871-3E45-4D11-A351-E761FAADCB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972EE-441C-4F55-8652-0FC6AA39DD1C}" type="datetimeFigureOut">
              <a:rPr lang="en-US" smtClean="0"/>
              <a:t>11/1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D0E4CE-EA42-43C6-BB53-58A037FE0B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3734D1-BA1C-4BD3-8721-F4635835C4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08014D-84B6-4C3F-9655-0787B3CC1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41281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BE4416-9A08-4F0B-8121-40E6708D5E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C1B65A1-AFFA-4A9C-9453-236BABD1E9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A9BA8C-C2F2-4A2F-A043-48E9A54A62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972EE-441C-4F55-8652-0FC6AA39DD1C}" type="datetimeFigureOut">
              <a:rPr lang="en-US" smtClean="0"/>
              <a:t>11/1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B80EB0-D258-4479-B09F-9574AD7571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9D72E2-F9D1-406B-BE6A-949D7B7C36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08014D-84B6-4C3F-9655-0787B3CC1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38986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780B72-2B41-4689-B8CB-AAFAC74CEF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B567B09-FD5A-4043-A614-38EA772ACF6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FFCDEF-E2F5-4036-9EB0-5C735AFC84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B8E37D-BFC9-480A-AB80-C7F9513B99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972EE-441C-4F55-8652-0FC6AA39DD1C}" type="datetimeFigureOut">
              <a:rPr lang="en-US" smtClean="0"/>
              <a:t>11/1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896452E-DF59-4166-8E6A-1DA489FF25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1A002D-5270-439F-88B6-4406BFA645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08014D-84B6-4C3F-9655-0787B3CC1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45544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C10D18-4D49-4F9B-B49B-5D53441FE1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902D54-263C-418A-AF09-88B39521D1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F8C9832-4049-4F69-A865-A8A896DBF7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1AC93DA-6113-4F14-9E2D-59A0347E4BF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19E4F5C-225C-4582-BA9A-975EEFD7E5A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08B0984-83E3-424E-84C7-9EA965E111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972EE-441C-4F55-8652-0FC6AA39DD1C}" type="datetimeFigureOut">
              <a:rPr lang="en-US" smtClean="0"/>
              <a:t>11/18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137079A-2AE6-45D2-B927-832DAE04A5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3E6316B-14CF-4A5D-A2F3-FDEA4B1A62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08014D-84B6-4C3F-9655-0787B3CC1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14385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120B01-51BB-46AC-999A-FC190CF6EA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B2D52A2-145E-4071-84B0-B4C2A030B7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972EE-441C-4F55-8652-0FC6AA39DD1C}" type="datetimeFigureOut">
              <a:rPr lang="en-US" smtClean="0"/>
              <a:t>11/18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5ED322F-E7D2-4007-BA18-C6B362B9E5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FC88E73-99E2-4B0E-89F5-40AB881E5C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08014D-84B6-4C3F-9655-0787B3CC1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48206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17EAAB8-20CD-415A-B26A-8F42FB9731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972EE-441C-4F55-8652-0FC6AA39DD1C}" type="datetimeFigureOut">
              <a:rPr lang="en-US" smtClean="0"/>
              <a:t>11/18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5D82610-B1B5-4CD6-B14A-66EEC4501E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DAEC594-009D-4817-B9EA-7401474E97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08014D-84B6-4C3F-9655-0787B3CC1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96015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829344-6510-4093-A1F6-68D8888A58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355679-77C3-4688-95A7-EAFFA4F814E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F6AFA7A-5ED2-4981-8E07-D7C818BF28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D146C1-6ECF-4BCC-B02E-FE227C9C5C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972EE-441C-4F55-8652-0FC6AA39DD1C}" type="datetimeFigureOut">
              <a:rPr lang="en-US" smtClean="0"/>
              <a:t>11/1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9CC37F-624C-45E6-BD9F-9256E7404B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AA917E7-7E65-48D6-A1DB-035C232496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08014D-84B6-4C3F-9655-0787B3CC1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70123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FFC346-4800-4AD6-B08B-FE9232C1E1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CFC68CC-5663-4553-85E1-FF1F7FD4F30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969C6A2-D2D2-4CBE-BA19-D7AF93581D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B2C217-858D-4DEC-87E1-68CB154CCB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972EE-441C-4F55-8652-0FC6AA39DD1C}" type="datetimeFigureOut">
              <a:rPr lang="en-US" smtClean="0"/>
              <a:t>11/1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5B1921-AD2E-474B-9E68-D623433077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4F9E8BA-8E40-4DB8-B80C-D889DE6C66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08014D-84B6-4C3F-9655-0787B3CC1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21317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E0E8A8A-E39C-4D8C-BD8E-E4FD7E2C39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4E2828-CA13-4D39-86B5-3BF4DCA149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149F07-58C3-400B-A56B-EB0F5ADA750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B972EE-441C-4F55-8652-0FC6AA39DD1C}" type="datetimeFigureOut">
              <a:rPr lang="en-US" smtClean="0"/>
              <a:t>11/1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914A02-1E19-4AD5-B4EF-426D38EED9A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34B90F-8BE3-4446-8731-D0C6585C702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08014D-84B6-4C3F-9655-0787B3CC1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5155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4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13FCB56A-68F9-40CF-B270-918C5E41CA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65909" y="5352761"/>
            <a:ext cx="10515600" cy="1325563"/>
          </a:xfrm>
        </p:spPr>
        <p:txBody>
          <a:bodyPr/>
          <a:lstStyle/>
          <a:p>
            <a:r>
              <a:rPr lang="en-US" dirty="0"/>
              <a:t>Library </a:t>
            </a:r>
            <a:r>
              <a:rPr lang="en-US"/>
              <a:t>size overview</a:t>
            </a:r>
          </a:p>
        </p:txBody>
      </p:sp>
      <p:pic>
        <p:nvPicPr>
          <p:cNvPr id="8" name="Content Placeholder 7">
            <a:extLst>
              <a:ext uri="{FF2B5EF4-FFF2-40B4-BE49-F238E27FC236}">
                <a16:creationId xmlns:a16="http://schemas.microsoft.com/office/drawing/2014/main" id="{F93B3CDB-570D-44AB-B19E-6344C71C8AB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5402" y="835530"/>
            <a:ext cx="7367016" cy="3810000"/>
          </a:xfrm>
        </p:spPr>
      </p:pic>
    </p:spTree>
    <p:extLst>
      <p:ext uri="{BB962C8B-B14F-4D97-AF65-F5344CB8AC3E}">
        <p14:creationId xmlns:p14="http://schemas.microsoft.com/office/powerpoint/2010/main" val="39984112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4F01D63B-0E40-4D15-8D92-77335A615A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35183" y="6179127"/>
            <a:ext cx="10515600" cy="554614"/>
          </a:xfrm>
        </p:spPr>
        <p:txBody>
          <a:bodyPr>
            <a:normAutofit/>
          </a:bodyPr>
          <a:lstStyle/>
          <a:p>
            <a:r>
              <a:rPr lang="en-US" sz="2000" dirty="0"/>
              <a:t>Figure S1: Alpha diversity analysis between the bulk soil and the rhizosphere soil</a:t>
            </a:r>
          </a:p>
        </p:txBody>
      </p:sp>
      <p:pic>
        <p:nvPicPr>
          <p:cNvPr id="8" name="Content Placeholder 7">
            <a:extLst>
              <a:ext uri="{FF2B5EF4-FFF2-40B4-BE49-F238E27FC236}">
                <a16:creationId xmlns:a16="http://schemas.microsoft.com/office/drawing/2014/main" id="{94135764-679E-4002-946C-2C22882969BD}"/>
              </a:ext>
            </a:extLst>
          </p:cNvPr>
          <p:cNvPicPr>
            <a:picLocks noGrp="1" noChangeAspect="1"/>
          </p:cNvPicPr>
          <p:nvPr>
            <p:ph sz="half"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28" r="34066" b="3472"/>
          <a:stretch/>
        </p:blipFill>
        <p:spPr>
          <a:xfrm>
            <a:off x="1620987" y="152400"/>
            <a:ext cx="3491348" cy="6082145"/>
          </a:xfrm>
        </p:spPr>
      </p:pic>
      <p:pic>
        <p:nvPicPr>
          <p:cNvPr id="10" name="Content Placeholder 9">
            <a:extLst>
              <a:ext uri="{FF2B5EF4-FFF2-40B4-BE49-F238E27FC236}">
                <a16:creationId xmlns:a16="http://schemas.microsoft.com/office/drawing/2014/main" id="{A39931B9-4EF2-4DBE-9930-01B8818FB8C9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23" b="3549"/>
          <a:stretch/>
        </p:blipFill>
        <p:spPr>
          <a:xfrm>
            <a:off x="5527963" y="194171"/>
            <a:ext cx="4807528" cy="5873926"/>
          </a:xfrm>
        </p:spPr>
      </p:pic>
    </p:spTree>
    <p:extLst>
      <p:ext uri="{BB962C8B-B14F-4D97-AF65-F5344CB8AC3E}">
        <p14:creationId xmlns:p14="http://schemas.microsoft.com/office/powerpoint/2010/main" val="29723465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8DAA6B-70BE-4615-9FA7-F1E6F177E5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5394325"/>
            <a:ext cx="10515600" cy="1325563"/>
          </a:xfrm>
        </p:spPr>
        <p:txBody>
          <a:bodyPr/>
          <a:lstStyle/>
          <a:p>
            <a:r>
              <a:rPr lang="en-US" dirty="0"/>
              <a:t>Beta diversity between the bulk and rhizosphere soil</a:t>
            </a:r>
          </a:p>
        </p:txBody>
      </p:sp>
      <p:pic>
        <p:nvPicPr>
          <p:cNvPr id="13" name="Content Placeholder 12">
            <a:extLst>
              <a:ext uri="{FF2B5EF4-FFF2-40B4-BE49-F238E27FC236}">
                <a16:creationId xmlns:a16="http://schemas.microsoft.com/office/drawing/2014/main" id="{3246322C-9448-4DB3-8F27-5014CB239C4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35578" y="620280"/>
            <a:ext cx="6265425" cy="4351338"/>
          </a:xfrm>
        </p:spPr>
      </p:pic>
    </p:spTree>
    <p:extLst>
      <p:ext uri="{BB962C8B-B14F-4D97-AF65-F5344CB8AC3E}">
        <p14:creationId xmlns:p14="http://schemas.microsoft.com/office/powerpoint/2010/main" val="12241684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07D791E6-2FBA-434D-8503-E43DD7C14B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9491" y="5408180"/>
            <a:ext cx="11471563" cy="1325563"/>
          </a:xfrm>
        </p:spPr>
        <p:txBody>
          <a:bodyPr>
            <a:normAutofit fontScale="90000"/>
          </a:bodyPr>
          <a:lstStyle/>
          <a:p>
            <a:r>
              <a:rPr lang="en-US" dirty="0"/>
              <a:t>Heat tree at the specie level showing the connections among the species at all levels of growth and bulk soil.</a:t>
            </a:r>
          </a:p>
        </p:txBody>
      </p:sp>
      <p:pic>
        <p:nvPicPr>
          <p:cNvPr id="8" name="Content Placeholder 7">
            <a:extLst>
              <a:ext uri="{FF2B5EF4-FFF2-40B4-BE49-F238E27FC236}">
                <a16:creationId xmlns:a16="http://schemas.microsoft.com/office/drawing/2014/main" id="{4A70839C-BBC4-4992-AA41-28FB69F112A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72691" y="0"/>
            <a:ext cx="6049329" cy="5292436"/>
          </a:xfrm>
        </p:spPr>
      </p:pic>
    </p:spTree>
    <p:extLst>
      <p:ext uri="{BB962C8B-B14F-4D97-AF65-F5344CB8AC3E}">
        <p14:creationId xmlns:p14="http://schemas.microsoft.com/office/powerpoint/2010/main" val="10529805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E1BD91-54FB-415E-ACCC-F497C1C3BF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16527" y="5214216"/>
            <a:ext cx="10515600" cy="1325563"/>
          </a:xfrm>
        </p:spPr>
        <p:txBody>
          <a:bodyPr/>
          <a:lstStyle/>
          <a:p>
            <a:r>
              <a:rPr lang="en-US" dirty="0"/>
              <a:t>Rarefaction curve</a:t>
            </a:r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878FD2A4-C089-41EA-83BF-22389884419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9387" y="731116"/>
            <a:ext cx="8460935" cy="4351338"/>
          </a:xfrm>
        </p:spPr>
      </p:pic>
    </p:spTree>
    <p:extLst>
      <p:ext uri="{BB962C8B-B14F-4D97-AF65-F5344CB8AC3E}">
        <p14:creationId xmlns:p14="http://schemas.microsoft.com/office/powerpoint/2010/main" val="324032406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31DDD9-49FC-4A5B-A3EA-1F8F769713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96637" y="5532437"/>
            <a:ext cx="10515600" cy="1325563"/>
          </a:xfrm>
        </p:spPr>
        <p:txBody>
          <a:bodyPr/>
          <a:lstStyle/>
          <a:p>
            <a:r>
              <a:rPr lang="en-US" dirty="0"/>
              <a:t>Random forest classification </a:t>
            </a:r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E71E312A-0C77-465C-B2DF-0468289DE16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2313" y="841952"/>
            <a:ext cx="4699445" cy="4351338"/>
          </a:xfrm>
        </p:spPr>
      </p:pic>
    </p:spTree>
    <p:extLst>
      <p:ext uri="{BB962C8B-B14F-4D97-AF65-F5344CB8AC3E}">
        <p14:creationId xmlns:p14="http://schemas.microsoft.com/office/powerpoint/2010/main" val="34969638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83</TotalTime>
  <Words>51</Words>
  <Application>Microsoft Office PowerPoint</Application>
  <PresentationFormat>Widescreen</PresentationFormat>
  <Paragraphs>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Library size overview</vt:lpstr>
      <vt:lpstr>Figure S1: Alpha diversity analysis between the bulk soil and the rhizosphere soil</vt:lpstr>
      <vt:lpstr>Beta diversity between the bulk and rhizosphere soil</vt:lpstr>
      <vt:lpstr>Heat tree at the specie level showing the connections among the species at all levels of growth and bulk soil.</vt:lpstr>
      <vt:lpstr>Rarefaction curve</vt:lpstr>
      <vt:lpstr>Random forest classification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luwaseyi olanrewaju</dc:creator>
  <cp:lastModifiedBy>oluwaseyi olanrewaju</cp:lastModifiedBy>
  <cp:revision>6</cp:revision>
  <dcterms:created xsi:type="dcterms:W3CDTF">2021-11-18T12:20:18Z</dcterms:created>
  <dcterms:modified xsi:type="dcterms:W3CDTF">2021-11-22T16:03:24Z</dcterms:modified>
</cp:coreProperties>
</file>